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758C95-E180-4512-A375-AE730D2D11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473329-67E1-4219-814D-B271E4B105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23D12D-839A-478F-8BB1-73AEB9EE8A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89F293-BA19-48BD-81CF-3B5CB8FE0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6886F3-BD80-49F1-B70A-03666C600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8633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175719-670D-4DB5-A683-9E46F0187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251D5D-D97C-4632-8675-948230053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900DC-3757-44F8-9670-816561466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23D8C-57EB-417A-9D51-38EC59B1C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96A9DF-B0BF-470E-AEF7-F69405047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6102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215E0E-8151-46AC-B87D-44CA3C7CD5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11D06C-9D2D-4F73-9D5D-7030D70285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503AAC-E241-4CD5-81C0-5315E5879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80507-0C63-4C67-A364-814147125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28540C-665F-486D-A17E-D6DDC0862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2500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2ABD2-E003-47B9-9E7E-76CCC27B9F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35C909-F818-4739-9038-6114407652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5F5328-589D-4084-8F7E-D1D7CB89B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04EB1F-BC5D-41C9-B58B-1AE71F937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2BE66E-1E5F-4E48-B281-57CF8CC93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53234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454307-D93F-4412-BD2B-50BC805697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21DBB3-830F-411E-A500-CF0C5E369C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B72D0D-B9E9-48D7-AD71-7C0923CEE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F1B3F8-09D6-41F4-B678-2CFA96AE7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0D47FC-D6E2-4CDA-ADB7-FF0989A9A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071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50A22-A615-44AF-8364-2264C9D76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FEEE4C-3BCD-4B63-B303-B65C3A1C86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C73244-488B-4A39-AC5A-0CA0ADE637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113799-D3E7-4FBE-BECD-F71EDFE6F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4F6CBD-9362-4A7B-9DCA-10D5FD82A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F555D3-36C2-4A61-A00A-1E228814F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1729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AF78E-FAB5-4940-A570-7E3949597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0614E8-1E80-451B-8580-DC302B1200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1AA039-B2CE-48BC-8473-4261EB5C16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96AACB-627D-41C4-8336-EE91B98C00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85AA8D-F5A0-4445-9B26-7CA41B3D3D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21AF0AD-74E9-4C1C-AA70-00D4E3A50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62807D-956B-4613-A76E-A99947D32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74321E-1CB8-4F9C-8BA2-08CAB4A5D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5926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04C759-3EDD-4941-8898-5D8E6ADA3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86AFCF6-EFEB-4F60-9CFD-6A9A298B2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16D006-47E1-47DC-9302-0AB6601EF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D98D54-0D9E-4E1B-BE64-005D4AA11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7860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DB1822-7FEA-4ECF-B948-F1462BCD8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F83538-2B61-46E3-937B-9D717EDE1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BC1C80-AB26-4C94-8729-4A7FBBEFE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5606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0CF144-067A-4EF8-B792-02FA417ED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18DDB9-AD07-4ED6-B017-7AEF1F939F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44C8B3-C299-44EA-8929-D6C66B4982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3E4DB1-1455-4B39-9F9E-091DD1C19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F24F99-DB15-4DC5-855C-A8E42F612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D17943-3489-48C3-B2CA-82DDCC7CF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0556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AF8AF-1A2A-4A7D-B61C-AD437CB5F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5B97C4-0CDA-495D-AEB6-82FE2465D0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3C527-969A-49EF-B4E8-18E8E0A2C3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6BEDCC-DEE9-4BCB-8F53-7C6763B05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D66EEC-D176-442D-ACD6-D7BD4757E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541AD2-FEEC-46C6-9F41-B1CC6EFD9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2242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EA9DB8-A2D5-4605-81A8-ECC8C494CF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4A4974-8877-4BD4-93A0-F7AC4737F7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33E94D-E9A6-408C-9270-AEEAD79485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7FEDAA-B0E7-4132-81FE-1C873855E65E}" type="datetimeFigureOut">
              <a:rPr lang="en-CA" smtClean="0"/>
              <a:t>2018-05-0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02707C-9D71-4016-9539-50E20D957B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0EC374-5DB9-4D07-9944-39CCDC5314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E1FE6-260B-4DE5-89E7-C0141EF5BB9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83470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632FEA07-331A-43DD-8F8E-B33DC0669488}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1F25CDA9-A461-4D4F-8590-DF8095B06F1D}"/>
              </a:ext>
            </a:extLst>
          </p:cNvPr>
          <p:cNvGrpSpPr/>
          <p:nvPr/>
        </p:nvGrpSpPr>
        <p:grpSpPr>
          <a:xfrm>
            <a:off x="657131" y="253219"/>
            <a:ext cx="11159091" cy="4420161"/>
            <a:chOff x="516454" y="886265"/>
            <a:chExt cx="11159091" cy="442016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546A65B-6FA9-481C-A1A8-513D87F368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5977" r="8472" b="19571"/>
            <a:stretch/>
          </p:blipFill>
          <p:spPr>
            <a:xfrm>
              <a:off x="516454" y="886265"/>
              <a:ext cx="11159091" cy="442016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B7B7146-0E15-476B-9D49-663895536A89}"/>
                </a:ext>
              </a:extLst>
            </p:cNvPr>
            <p:cNvSpPr txBox="1"/>
            <p:nvPr/>
          </p:nvSpPr>
          <p:spPr>
            <a:xfrm>
              <a:off x="1678222" y="1191576"/>
              <a:ext cx="97474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Control</a:t>
              </a:r>
            </a:p>
            <a:p>
              <a:r>
                <a:rPr lang="en-CA" dirty="0">
                  <a:solidFill>
                    <a:schemeClr val="bg1"/>
                  </a:solidFill>
                </a:rPr>
                <a:t>No dy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EA8C71E-2452-44B9-ADD1-DB839E7AF012}"/>
                </a:ext>
              </a:extLst>
            </p:cNvPr>
            <p:cNvSpPr txBox="1"/>
            <p:nvPr/>
          </p:nvSpPr>
          <p:spPr>
            <a:xfrm>
              <a:off x="2846642" y="1160621"/>
              <a:ext cx="95415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Hoechst 3334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9FDE1D-EE37-4AF8-8EBD-AC53ABD67139}"/>
                </a:ext>
              </a:extLst>
            </p:cNvPr>
            <p:cNvSpPr txBox="1"/>
            <p:nvPr/>
          </p:nvSpPr>
          <p:spPr>
            <a:xfrm>
              <a:off x="4092345" y="1160621"/>
              <a:ext cx="95415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SYBR Gol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28C5310-5306-4B30-ACBD-B1E3E910E395}"/>
                </a:ext>
              </a:extLst>
            </p:cNvPr>
            <p:cNvSpPr txBox="1"/>
            <p:nvPr/>
          </p:nvSpPr>
          <p:spPr>
            <a:xfrm>
              <a:off x="5338049" y="1160621"/>
              <a:ext cx="113378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err="1">
                  <a:solidFill>
                    <a:schemeClr val="bg1"/>
                  </a:solidFill>
                </a:rPr>
                <a:t>SafeView</a:t>
              </a:r>
              <a:r>
                <a:rPr lang="en-CA" dirty="0">
                  <a:solidFill>
                    <a:schemeClr val="bg1"/>
                  </a:solidFill>
                </a:rPr>
                <a:t> Plu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4C2AE79-F247-47BD-9FBC-618F8CB256C4}"/>
                </a:ext>
              </a:extLst>
            </p:cNvPr>
            <p:cNvSpPr txBox="1"/>
            <p:nvPr/>
          </p:nvSpPr>
          <p:spPr>
            <a:xfrm>
              <a:off x="6551341" y="1249732"/>
              <a:ext cx="11337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LC Gree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6412154-55EF-466A-8F07-5D0EA886DE6D}"/>
                </a:ext>
              </a:extLst>
            </p:cNvPr>
            <p:cNvSpPr txBox="1"/>
            <p:nvPr/>
          </p:nvSpPr>
          <p:spPr>
            <a:xfrm>
              <a:off x="7858915" y="1111232"/>
              <a:ext cx="113378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EVA Gree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DD9BE9B-096B-49C9-9F4E-E2088A1A496E}"/>
                </a:ext>
              </a:extLst>
            </p:cNvPr>
            <p:cNvSpPr txBox="1"/>
            <p:nvPr/>
          </p:nvSpPr>
          <p:spPr>
            <a:xfrm>
              <a:off x="9104618" y="1111231"/>
              <a:ext cx="121628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err="1">
                  <a:solidFill>
                    <a:schemeClr val="bg1"/>
                  </a:solidFill>
                </a:rPr>
                <a:t>Propidium</a:t>
              </a:r>
              <a:r>
                <a:rPr lang="en-CA" dirty="0">
                  <a:solidFill>
                    <a:schemeClr val="bg1"/>
                  </a:solidFill>
                </a:rPr>
                <a:t> Iodid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6F7C3A0-B8E8-4840-8744-9CB0AAA30CE1}"/>
                </a:ext>
              </a:extLst>
            </p:cNvPr>
            <p:cNvSpPr txBox="1"/>
            <p:nvPr/>
          </p:nvSpPr>
          <p:spPr>
            <a:xfrm>
              <a:off x="10541765" y="1111230"/>
              <a:ext cx="113378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err="1">
                  <a:solidFill>
                    <a:schemeClr val="bg1"/>
                  </a:solidFill>
                </a:rPr>
                <a:t>SafeView</a:t>
              </a:r>
              <a:r>
                <a:rPr lang="en-CA" dirty="0">
                  <a:solidFill>
                    <a:schemeClr val="bg1"/>
                  </a:solidFill>
                </a:rPr>
                <a:t> Classi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9E85CE7-F96C-4EF9-BCCF-A33297188385}"/>
                </a:ext>
              </a:extLst>
            </p:cNvPr>
            <p:cNvSpPr txBox="1"/>
            <p:nvPr/>
          </p:nvSpPr>
          <p:spPr>
            <a:xfrm>
              <a:off x="587863" y="1970497"/>
              <a:ext cx="993913" cy="3710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SDS</a:t>
              </a:r>
              <a:r>
                <a:rPr lang="en-CA" dirty="0"/>
                <a:t> 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8C5B0C9-8CAA-47AB-8A02-4AB776D6D1D7}"/>
                </a:ext>
              </a:extLst>
            </p:cNvPr>
            <p:cNvSpPr txBox="1"/>
            <p:nvPr/>
          </p:nvSpPr>
          <p:spPr>
            <a:xfrm>
              <a:off x="587862" y="3726411"/>
              <a:ext cx="1146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Tween 20</a:t>
              </a:r>
              <a:r>
                <a:rPr lang="en-CA" dirty="0"/>
                <a:t>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0B21A24-5F27-403B-83FB-EFEB9AD0E330}"/>
                </a:ext>
              </a:extLst>
            </p:cNvPr>
            <p:cNvSpPr txBox="1"/>
            <p:nvPr/>
          </p:nvSpPr>
          <p:spPr>
            <a:xfrm>
              <a:off x="587863" y="4157108"/>
              <a:ext cx="11463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 err="1">
                  <a:solidFill>
                    <a:schemeClr val="bg1"/>
                  </a:solidFill>
                </a:rPr>
                <a:t>Igepal</a:t>
              </a:r>
              <a:r>
                <a:rPr lang="en-CA" dirty="0">
                  <a:solidFill>
                    <a:schemeClr val="bg1"/>
                  </a:solidFill>
                </a:rPr>
                <a:t> 630</a:t>
              </a:r>
              <a:r>
                <a:rPr lang="en-CA" dirty="0"/>
                <a:t>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B9339A3-AFAA-4C50-8640-1123A8943B28}"/>
                </a:ext>
              </a:extLst>
            </p:cNvPr>
            <p:cNvSpPr txBox="1"/>
            <p:nvPr/>
          </p:nvSpPr>
          <p:spPr>
            <a:xfrm>
              <a:off x="587863" y="4687193"/>
              <a:ext cx="993913" cy="3710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Brij 35</a:t>
              </a:r>
              <a:r>
                <a:rPr lang="en-CA" dirty="0"/>
                <a:t>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74628EE-0CEA-4803-B4B9-F8C2D512BF69}"/>
                </a:ext>
              </a:extLst>
            </p:cNvPr>
            <p:cNvSpPr txBox="1"/>
            <p:nvPr/>
          </p:nvSpPr>
          <p:spPr>
            <a:xfrm>
              <a:off x="574608" y="2418189"/>
              <a:ext cx="993913" cy="3710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TE only</a:t>
              </a:r>
              <a:r>
                <a:rPr lang="en-CA" dirty="0"/>
                <a:t>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F7272DA-DC5A-464A-BD7A-8B0BC0D28331}"/>
                </a:ext>
              </a:extLst>
            </p:cNvPr>
            <p:cNvSpPr txBox="1"/>
            <p:nvPr/>
          </p:nvSpPr>
          <p:spPr>
            <a:xfrm>
              <a:off x="541479" y="2892390"/>
              <a:ext cx="13914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Triton X-100</a:t>
              </a:r>
              <a:r>
                <a:rPr lang="en-CA" dirty="0"/>
                <a:t> 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BDBBF07-B727-4279-97CE-6B691505DBAE}"/>
                </a:ext>
              </a:extLst>
            </p:cNvPr>
            <p:cNvSpPr txBox="1"/>
            <p:nvPr/>
          </p:nvSpPr>
          <p:spPr>
            <a:xfrm>
              <a:off x="587862" y="3324667"/>
              <a:ext cx="993913" cy="3710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dirty="0">
                  <a:solidFill>
                    <a:schemeClr val="bg1"/>
                  </a:solidFill>
                </a:rPr>
                <a:t>NP 40</a:t>
              </a:r>
              <a:r>
                <a:rPr lang="en-CA" dirty="0"/>
                <a:t> 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861AD30-5079-48B8-8C04-5592FA94A4E6}"/>
                </a:ext>
              </a:extLst>
            </p:cNvPr>
            <p:cNvSpPr txBox="1"/>
            <p:nvPr/>
          </p:nvSpPr>
          <p:spPr>
            <a:xfrm>
              <a:off x="516454" y="1368694"/>
              <a:ext cx="9939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solidFill>
                    <a:schemeClr val="bg1"/>
                  </a:solidFill>
                </a:rPr>
                <a:t>1% Surfactants:</a:t>
              </a:r>
              <a:endParaRPr lang="en-CA" sz="1200" dirty="0"/>
            </a:p>
          </p:txBody>
        </p:sp>
      </p:grpSp>
      <p:sp>
        <p:nvSpPr>
          <p:cNvPr id="24" name="Rectangle 23">
            <a:extLst>
              <a:ext uri="{FF2B5EF4-FFF2-40B4-BE49-F238E27FC236}">
                <a16:creationId xmlns:a16="http://schemas.microsoft.com/office/drawing/2014/main" id="{14CC11F4-265E-4B26-B46E-DD5731901EAB}"/>
              </a:ext>
            </a:extLst>
          </p:cNvPr>
          <p:cNvSpPr/>
          <p:nvPr/>
        </p:nvSpPr>
        <p:spPr>
          <a:xfrm>
            <a:off x="657131" y="4842115"/>
            <a:ext cx="11356678" cy="16749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CA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. Fluorescence of DNA-binding dyes emulsified with various surfactants. Fluorescence of </a:t>
            </a:r>
            <a:r>
              <a:rPr lang="en-CA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feView</a:t>
            </a:r>
            <a:r>
              <a:rPr lang="en-CA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us, LC Green, and EVA Green is less intense in this experiment due to lower concentrations these dyes are sold at; microscopic examination still revealed auto-fluorescing particles present. 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1822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0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Dlusskaya</dc:creator>
  <cp:lastModifiedBy>Elena Dlusskaya</cp:lastModifiedBy>
  <cp:revision>1</cp:revision>
  <dcterms:created xsi:type="dcterms:W3CDTF">2018-05-07T17:56:54Z</dcterms:created>
  <dcterms:modified xsi:type="dcterms:W3CDTF">2018-05-07T17:58:10Z</dcterms:modified>
</cp:coreProperties>
</file>